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6" roundtripDataSignature="AMtx7mjk78i/BKlQ73cBfYAT3W2xcKuWM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png"/><Relationship Id="rId4" Type="http://schemas.openxmlformats.org/officeDocument/2006/relationships/image" Target="../media/image4.png"/><Relationship Id="rId5" Type="http://schemas.openxmlformats.org/officeDocument/2006/relationships/image" Target="../media/image3.png"/><Relationship Id="rId6" Type="http://schemas.openxmlformats.org/officeDocument/2006/relationships/image" Target="../media/image2.png"/><Relationship Id="rId7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829733" y="270934"/>
            <a:ext cx="10261500" cy="6465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Annotation manual curation. Detection of missannotated L1Tc genes in Uniprot as Trans-sialidases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85" name="Google Shape;85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22828" y="2094004"/>
            <a:ext cx="5142484" cy="3936096"/>
          </a:xfrm>
          <a:prstGeom prst="rect">
            <a:avLst/>
          </a:prstGeom>
          <a:noFill/>
          <a:ln>
            <a:noFill/>
          </a:ln>
        </p:spPr>
      </p:pic>
      <p:sp>
        <p:nvSpPr>
          <p:cNvPr id="86" name="Google Shape;86;p1"/>
          <p:cNvSpPr/>
          <p:nvPr/>
        </p:nvSpPr>
        <p:spPr>
          <a:xfrm>
            <a:off x="1981200" y="2681132"/>
            <a:ext cx="719667" cy="651933"/>
          </a:xfrm>
          <a:prstGeom prst="ellipse">
            <a:avLst/>
          </a:prstGeom>
          <a:noFill/>
          <a:ln cap="flat" cmpd="sng" w="12700">
            <a:solidFill>
              <a:srgbClr val="674EA7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"/>
          <p:cNvSpPr txBox="1"/>
          <p:nvPr/>
        </p:nvSpPr>
        <p:spPr>
          <a:xfrm>
            <a:off x="5960533" y="1182468"/>
            <a:ext cx="504961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. Manual retrieve of uniprot record annotated in gff: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8" name="Google Shape;88;p1"/>
          <p:cNvSpPr txBox="1"/>
          <p:nvPr/>
        </p:nvSpPr>
        <p:spPr>
          <a:xfrm>
            <a:off x="647830" y="1182469"/>
            <a:ext cx="5049610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. Mafft alignment of genes annotated as trans-sialidases + trans-sialidases groups obtained from Bartholomeu et al 2011. Circle: genes with no homology with previous reported groups. 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5960533" y="3342802"/>
            <a:ext cx="504961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. Blast of nt using nr database: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0" name="Google Shape;90;p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5881071" y="2297617"/>
            <a:ext cx="6005807" cy="959664"/>
          </a:xfrm>
          <a:prstGeom prst="rect">
            <a:avLst/>
          </a:prstGeom>
          <a:noFill/>
          <a:ln>
            <a:noFill/>
          </a:ln>
        </p:spPr>
      </p:pic>
      <p:pic>
        <p:nvPicPr>
          <p:cNvPr id="91" name="Google Shape;91;p1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5982639" y="1558050"/>
            <a:ext cx="6120000" cy="110347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p1"/>
          <p:cNvPicPr preferRelativeResize="0"/>
          <p:nvPr/>
        </p:nvPicPr>
        <p:blipFill rotWithShape="1">
          <a:blip r:embed="rId6">
            <a:alphaModFix/>
          </a:blip>
          <a:srcRect b="0" l="1443" r="0" t="0"/>
          <a:stretch/>
        </p:blipFill>
        <p:spPr>
          <a:xfrm>
            <a:off x="5665312" y="3701231"/>
            <a:ext cx="6437327" cy="821917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p1"/>
          <p:cNvSpPr txBox="1"/>
          <p:nvPr/>
        </p:nvSpPr>
        <p:spPr>
          <a:xfrm>
            <a:off x="5960533" y="1841725"/>
            <a:ext cx="504961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. Annotated as “Putative trans-sialidase” in Uniprot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"/>
          <p:cNvSpPr/>
          <p:nvPr/>
        </p:nvSpPr>
        <p:spPr>
          <a:xfrm>
            <a:off x="5462135" y="4336332"/>
            <a:ext cx="188339" cy="139469"/>
          </a:xfrm>
          <a:prstGeom prst="rightArrow">
            <a:avLst>
              <a:gd fmla="val 50000" name="adj1"/>
              <a:gd fmla="val 50000" name="adj2"/>
            </a:avLst>
          </a:prstGeom>
          <a:solidFill>
            <a:srgbClr val="FF0000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"/>
          <p:cNvSpPr txBox="1"/>
          <p:nvPr/>
        </p:nvSpPr>
        <p:spPr>
          <a:xfrm>
            <a:off x="5960533" y="4823579"/>
            <a:ext cx="504961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. Check new annotation: find motifs associated to trans-sialidases. 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96;p1"/>
          <p:cNvSpPr txBox="1"/>
          <p:nvPr/>
        </p:nvSpPr>
        <p:spPr>
          <a:xfrm>
            <a:off x="5960533" y="5383994"/>
            <a:ext cx="5049610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. Change gff annotation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7" name="Google Shape;97;p1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5823975" y="5865426"/>
            <a:ext cx="6120000" cy="9044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5-27T19:29:59Z</dcterms:created>
  <dc:creator>Gonzalo Greif</dc:creator>
</cp:coreProperties>
</file>